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9027" autoAdjust="0"/>
  </p:normalViewPr>
  <p:slideViewPr>
    <p:cSldViewPr snapToGrid="0" snapToObjects="1" showGuides="1">
      <p:cViewPr>
        <p:scale>
          <a:sx n="150" d="100"/>
          <a:sy n="150" d="100"/>
        </p:scale>
        <p:origin x="-560" y="4744"/>
      </p:cViewPr>
      <p:guideLst>
        <p:guide orient="horz" pos="2880"/>
        <p:guide pos="325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enghuixing:Desktop:6-22-12(v5p139-140):Summary(v5p139-140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>
        <c:manualLayout>
          <c:layoutTarget val="inner"/>
          <c:xMode val="edge"/>
          <c:yMode val="edge"/>
          <c:x val="0.108570780933402"/>
          <c:y val="0.116959064327485"/>
          <c:w val="0.844306806372083"/>
          <c:h val="0.522164203158816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Final!$G$24:$G$29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300000000000001</c:v>
                  </c:pt>
                  <c:pt idx="2">
                    <c:v>0.249999999999998</c:v>
                  </c:pt>
                  <c:pt idx="3">
                    <c:v>0.0999999999999989</c:v>
                  </c:pt>
                  <c:pt idx="4">
                    <c:v>0.0</c:v>
                  </c:pt>
                  <c:pt idx="5">
                    <c:v>0.149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Final!$B$24:$B$29</c:f>
              <c:strCache>
                <c:ptCount val="6"/>
                <c:pt idx="0">
                  <c:v>Tip41</c:v>
                </c:pt>
                <c:pt idx="1">
                  <c:v>AT3G20810</c:v>
                </c:pt>
                <c:pt idx="2">
                  <c:v>AT3G22380</c:v>
                </c:pt>
                <c:pt idx="3">
                  <c:v>AT3G26640</c:v>
                </c:pt>
                <c:pt idx="4">
                  <c:v>AT5G48890</c:v>
                </c:pt>
                <c:pt idx="5">
                  <c:v>AT5G52910</c:v>
                </c:pt>
              </c:strCache>
            </c:strRef>
          </c:cat>
          <c:val>
            <c:numRef>
              <c:f>Final!$F$24:$F$29</c:f>
              <c:numCache>
                <c:formatCode>0.0</c:formatCode>
                <c:ptCount val="6"/>
                <c:pt idx="0">
                  <c:v>1.0</c:v>
                </c:pt>
                <c:pt idx="1">
                  <c:v>3.482202253184498</c:v>
                </c:pt>
                <c:pt idx="2">
                  <c:v>4.43827788827138</c:v>
                </c:pt>
                <c:pt idx="3">
                  <c:v>3.999999999999995</c:v>
                </c:pt>
                <c:pt idx="4">
                  <c:v>2.639015821545787</c:v>
                </c:pt>
                <c:pt idx="5">
                  <c:v>2.549121254638526</c:v>
                </c:pt>
              </c:numCache>
            </c:numRef>
          </c:val>
        </c:ser>
        <c:dLbls/>
        <c:axId val="556915720"/>
        <c:axId val="557045048"/>
      </c:barChart>
      <c:catAx>
        <c:axId val="556915720"/>
        <c:scaling>
          <c:orientation val="minMax"/>
        </c:scaling>
        <c:axPos val="b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 i="0"/>
            </a:pPr>
            <a:endParaRPr lang="en-US"/>
          </a:p>
        </c:txPr>
        <c:crossAx val="557045048"/>
        <c:crosses val="autoZero"/>
        <c:auto val="1"/>
        <c:lblAlgn val="ctr"/>
        <c:lblOffset val="100"/>
      </c:catAx>
      <c:valAx>
        <c:axId val="557045048"/>
        <c:scaling>
          <c:orientation val="minMax"/>
        </c:scaling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" sourceLinked="0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 i="0" baseline="0"/>
            </a:pPr>
            <a:endParaRPr lang="en-US"/>
          </a:p>
        </c:txPr>
        <c:crossAx val="556915720"/>
        <c:crosses val="autoZero"/>
        <c:crossBetween val="between"/>
        <c:majorUnit val="1.0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F18EC-2BE5-E948-9812-54AFECA18A06}" type="datetimeFigureOut">
              <a:rPr lang="en-US" smtClean="0"/>
              <a:pPr/>
              <a:t>10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A2883-B8C9-F14B-8832-01402438AA4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1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00259" y="1477733"/>
            <a:ext cx="1204592" cy="908018"/>
            <a:chOff x="521354" y="5907649"/>
            <a:chExt cx="1204592" cy="908018"/>
          </a:xfrm>
        </p:grpSpPr>
        <p:sp>
          <p:nvSpPr>
            <p:cNvPr id="3" name="Text Box 4"/>
            <p:cNvSpPr txBox="1">
              <a:spLocks noChangeArrowheads="1"/>
            </p:cNvSpPr>
            <p:nvPr/>
          </p:nvSpPr>
          <p:spPr bwMode="auto">
            <a:xfrm rot="19016651">
              <a:off x="521354" y="5965360"/>
              <a:ext cx="595122" cy="246221"/>
            </a:xfrm>
            <a:prstGeom prst="rect">
              <a:avLst/>
            </a:prstGeom>
            <a:noFill/>
            <a:ln w="12700" cap="sq">
              <a:noFill/>
              <a:miter lim="800000"/>
              <a:headEnd type="none" w="sm" len="sm"/>
              <a:tailEnd type="none" w="sm" len="sm"/>
            </a:ln>
            <a:effectLst/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000" i="1" dirty="0" smtClean="0"/>
                <a:t>pcfs4-1</a:t>
              </a:r>
              <a:endParaRPr lang="en-US" sz="1000" i="1" dirty="0"/>
            </a:p>
          </p:txBody>
        </p:sp>
        <p:grpSp>
          <p:nvGrpSpPr>
            <p:cNvPr id="4" name="Group 74"/>
            <p:cNvGrpSpPr/>
            <p:nvPr/>
          </p:nvGrpSpPr>
          <p:grpSpPr>
            <a:xfrm>
              <a:off x="609600" y="6299200"/>
              <a:ext cx="948267" cy="516467"/>
              <a:chOff x="4140200" y="5308600"/>
              <a:chExt cx="1494895" cy="901700"/>
            </a:xfrm>
          </p:grpSpPr>
          <p:grpSp>
            <p:nvGrpSpPr>
              <p:cNvPr id="6" name="Group 71"/>
              <p:cNvGrpSpPr/>
              <p:nvPr/>
            </p:nvGrpSpPr>
            <p:grpSpPr>
              <a:xfrm>
                <a:off x="4144433" y="5319184"/>
                <a:ext cx="1490662" cy="865716"/>
                <a:chOff x="4144433" y="5319184"/>
                <a:chExt cx="1490662" cy="865716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144433" y="5319184"/>
                  <a:ext cx="1481667" cy="412750"/>
                </a:xfrm>
                <a:prstGeom prst="rect">
                  <a:avLst/>
                </a:prstGeom>
                <a:ln>
                  <a:noFill/>
                </a:ln>
              </p:spPr>
            </p:pic>
            <p:pic>
              <p:nvPicPr>
                <p:cNvPr id="9" name="Picture 83" descr="EqualLoading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4144433" y="5767389"/>
                  <a:ext cx="1490662" cy="4175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7" name="Rectangle 6"/>
              <p:cNvSpPr/>
              <p:nvPr/>
            </p:nvSpPr>
            <p:spPr>
              <a:xfrm>
                <a:off x="4140200" y="5308600"/>
                <a:ext cx="1485900" cy="9017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" name="Text Box 4"/>
            <p:cNvSpPr txBox="1">
              <a:spLocks noChangeArrowheads="1"/>
            </p:cNvSpPr>
            <p:nvPr/>
          </p:nvSpPr>
          <p:spPr bwMode="auto">
            <a:xfrm rot="19016651">
              <a:off x="961757" y="5907649"/>
              <a:ext cx="764189" cy="246221"/>
            </a:xfrm>
            <a:prstGeom prst="rect">
              <a:avLst/>
            </a:prstGeom>
            <a:noFill/>
            <a:ln w="12700" cap="sq">
              <a:noFill/>
              <a:miter lim="800000"/>
              <a:headEnd type="none" w="sm" len="sm"/>
              <a:tailEnd type="none" w="sm" len="sm"/>
            </a:ln>
            <a:effectLst/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000" i="1" dirty="0" smtClean="0"/>
                <a:t>PCFS4-TAP</a:t>
              </a:r>
              <a:endParaRPr lang="en-US" sz="1000" i="1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560354" y="620771"/>
            <a:ext cx="864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S1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835317" y="2605884"/>
            <a:ext cx="480906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cs typeface="Arial"/>
              </a:rPr>
              <a:t>Figure S1. Expression of PCFS4-TAP fusion protein in transgenic plants. The total protein extracts from the mutant (</a:t>
            </a:r>
            <a:r>
              <a:rPr lang="en-US" sz="1200" b="1" i="1" dirty="0" smtClean="0">
                <a:cs typeface="Arial"/>
              </a:rPr>
              <a:t>pcfs4-1</a:t>
            </a:r>
            <a:r>
              <a:rPr lang="en-US" sz="1200" dirty="0" smtClean="0">
                <a:cs typeface="Arial"/>
              </a:rPr>
              <a:t>) and the mutant containing the gene construct of </a:t>
            </a:r>
            <a:r>
              <a:rPr lang="en-US" sz="1200" i="1" dirty="0" smtClean="0">
                <a:cs typeface="Arial"/>
              </a:rPr>
              <a:t>35S:PCFS4-TAP </a:t>
            </a:r>
            <a:r>
              <a:rPr lang="en-US" sz="1200" dirty="0" smtClean="0">
                <a:cs typeface="Arial"/>
              </a:rPr>
              <a:t>(</a:t>
            </a:r>
            <a:r>
              <a:rPr lang="en-US" sz="1200" b="1" i="1" dirty="0" smtClean="0">
                <a:cs typeface="Arial"/>
              </a:rPr>
              <a:t>PCFS4-TAP</a:t>
            </a:r>
            <a:r>
              <a:rPr lang="en-US" sz="1200" dirty="0" smtClean="0">
                <a:cs typeface="Arial"/>
              </a:rPr>
              <a:t>)</a:t>
            </a:r>
            <a:r>
              <a:rPr lang="en-US" sz="1200" i="1" dirty="0" smtClean="0">
                <a:cs typeface="Arial"/>
              </a:rPr>
              <a:t> </a:t>
            </a:r>
            <a:r>
              <a:rPr lang="en-US" sz="1200" dirty="0" smtClean="0">
                <a:cs typeface="Arial"/>
              </a:rPr>
              <a:t>were fractioned, blotted to membrane and </a:t>
            </a:r>
            <a:r>
              <a:rPr lang="en-US" sz="1200" dirty="0" err="1" smtClean="0">
                <a:cs typeface="Arial"/>
              </a:rPr>
              <a:t>immuno</a:t>
            </a:r>
            <a:r>
              <a:rPr lang="en-US" sz="1200" dirty="0" smtClean="0">
                <a:cs typeface="Arial"/>
              </a:rPr>
              <a:t>-detected using </a:t>
            </a:r>
            <a:r>
              <a:rPr lang="en-US" sz="1200" dirty="0" smtClean="0"/>
              <a:t>peroxidase-conjugated anti-peroxidase </a:t>
            </a:r>
            <a:r>
              <a:rPr lang="en-US" sz="1200" dirty="0" err="1" smtClean="0"/>
              <a:t>IgG</a:t>
            </a:r>
            <a:r>
              <a:rPr lang="en-US" sz="1200" dirty="0" smtClean="0"/>
              <a:t> against the TAP tag (upper-panel).</a:t>
            </a:r>
            <a:r>
              <a:rPr lang="en-US" sz="1200" dirty="0" smtClean="0">
                <a:cs typeface="Arial"/>
              </a:rPr>
              <a:t> The </a:t>
            </a:r>
            <a:r>
              <a:rPr lang="en-US" sz="1200" dirty="0" err="1" smtClean="0"/>
              <a:t>Coomassie</a:t>
            </a:r>
            <a:r>
              <a:rPr lang="en-US" sz="1200" dirty="0" smtClean="0"/>
              <a:t> blue stained gel image (lower-panel) showed an equal loading for the two sample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/>
          <p:nvPr/>
        </p:nvGrpSpPr>
        <p:grpSpPr>
          <a:xfrm>
            <a:off x="1493795" y="893763"/>
            <a:ext cx="3087730" cy="2171700"/>
            <a:chOff x="198395" y="1002128"/>
            <a:chExt cx="3087730" cy="2171700"/>
          </a:xfrm>
        </p:grpSpPr>
        <p:graphicFrame>
          <p:nvGraphicFramePr>
            <p:cNvPr id="5" name="Chart 4"/>
            <p:cNvGraphicFramePr/>
            <p:nvPr/>
          </p:nvGraphicFramePr>
          <p:xfrm>
            <a:off x="321506" y="1002128"/>
            <a:ext cx="2964619" cy="2171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-134052" y="1653246"/>
              <a:ext cx="9111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Fold Change </a:t>
              </a:r>
              <a:endParaRPr lang="en-US" sz="1000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117603" y="3005667"/>
            <a:ext cx="393699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2. Verification of the PCFS4-TAP enrichment on the gene loci involved in </a:t>
            </a:r>
            <a:r>
              <a:rPr lang="en-US" sz="1200" dirty="0"/>
              <a:t>c</a:t>
            </a:r>
            <a:r>
              <a:rPr lang="en-US" sz="1200" dirty="0" smtClean="0"/>
              <a:t>ircadian </a:t>
            </a:r>
            <a:r>
              <a:rPr lang="en-US" sz="1200" dirty="0"/>
              <a:t>r</a:t>
            </a:r>
            <a:r>
              <a:rPr lang="en-US" sz="1200" dirty="0" smtClean="0"/>
              <a:t>hythm. Following the </a:t>
            </a:r>
            <a:r>
              <a:rPr lang="en-US" sz="1200" dirty="0" err="1" smtClean="0"/>
              <a:t>ChIP</a:t>
            </a:r>
            <a:r>
              <a:rPr lang="en-US" sz="1200" dirty="0" smtClean="0"/>
              <a:t>, the DNA abundance (mean ± </a:t>
            </a:r>
            <a:r>
              <a:rPr lang="en-US" sz="1200" dirty="0" err="1" smtClean="0"/>
              <a:t>stdev</a:t>
            </a:r>
            <a:r>
              <a:rPr lang="en-US" sz="1200" dirty="0" smtClean="0"/>
              <a:t>) of the PCFS4-TAP enriched sites were determined using </a:t>
            </a:r>
            <a:r>
              <a:rPr lang="en-US" sz="1200" dirty="0" err="1" smtClean="0"/>
              <a:t>qPCR</a:t>
            </a:r>
            <a:r>
              <a:rPr lang="en-US" sz="1200" dirty="0" smtClean="0"/>
              <a:t> and normalized to the PCFS4-TAP enrichment on Tip41 (the control).  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476500" y="392499"/>
            <a:ext cx="893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2</a:t>
            </a:r>
            <a:endParaRPr lang="en-US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1055531" y="503771"/>
            <a:ext cx="4140200" cy="1219018"/>
            <a:chOff x="1055531" y="503771"/>
            <a:chExt cx="4140200" cy="1219018"/>
          </a:xfrm>
        </p:grpSpPr>
        <p:grpSp>
          <p:nvGrpSpPr>
            <p:cNvPr id="15" name="Group 14"/>
            <p:cNvGrpSpPr/>
            <p:nvPr/>
          </p:nvGrpSpPr>
          <p:grpSpPr>
            <a:xfrm>
              <a:off x="1055531" y="681572"/>
              <a:ext cx="4140200" cy="1041217"/>
              <a:chOff x="1358900" y="571501"/>
              <a:chExt cx="4140200" cy="1041217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58900" y="571501"/>
                <a:ext cx="4140200" cy="673099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/>
              <a:srcRect b="47647"/>
              <a:stretch>
                <a:fillRect/>
              </a:stretch>
            </p:blipFill>
            <p:spPr>
              <a:xfrm>
                <a:off x="1358900" y="1286935"/>
                <a:ext cx="4140200" cy="325783"/>
              </a:xfrm>
              <a:prstGeom prst="rect">
                <a:avLst/>
              </a:prstGeom>
            </p:spPr>
          </p:pic>
        </p:grpSp>
        <p:sp>
          <p:nvSpPr>
            <p:cNvPr id="20" name="Rectangle 19"/>
            <p:cNvSpPr/>
            <p:nvPr/>
          </p:nvSpPr>
          <p:spPr>
            <a:xfrm>
              <a:off x="4660902" y="503771"/>
              <a:ext cx="333375" cy="12190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895727" y="503771"/>
              <a:ext cx="333375" cy="12190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1055531" y="2319679"/>
            <a:ext cx="1619794" cy="1219018"/>
            <a:chOff x="1055531" y="1811689"/>
            <a:chExt cx="1619794" cy="1219018"/>
          </a:xfrm>
        </p:grpSpPr>
        <p:grpSp>
          <p:nvGrpSpPr>
            <p:cNvPr id="16" name="Group 15"/>
            <p:cNvGrpSpPr/>
            <p:nvPr/>
          </p:nvGrpSpPr>
          <p:grpSpPr>
            <a:xfrm>
              <a:off x="1055531" y="1951756"/>
              <a:ext cx="1619794" cy="952315"/>
              <a:chOff x="1534400" y="1841685"/>
              <a:chExt cx="1619794" cy="95231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866901" y="1841685"/>
                <a:ext cx="1282700" cy="452784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5"/>
              <a:srcRect l="15319" r="30638" b="50704"/>
              <a:stretch>
                <a:fillRect/>
              </a:stretch>
            </p:blipFill>
            <p:spPr>
              <a:xfrm>
                <a:off x="1534400" y="2379143"/>
                <a:ext cx="1619794" cy="414857"/>
              </a:xfrm>
              <a:prstGeom prst="rect">
                <a:avLst/>
              </a:prstGeom>
            </p:spPr>
          </p:pic>
        </p:grpSp>
        <p:sp>
          <p:nvSpPr>
            <p:cNvPr id="22" name="Rectangle 21"/>
            <p:cNvSpPr/>
            <p:nvPr/>
          </p:nvSpPr>
          <p:spPr>
            <a:xfrm>
              <a:off x="1235632" y="1811689"/>
              <a:ext cx="333375" cy="12190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1055531" y="4115239"/>
            <a:ext cx="5063764" cy="1219018"/>
            <a:chOff x="1055531" y="4386167"/>
            <a:chExt cx="5063764" cy="1219018"/>
          </a:xfrm>
        </p:grpSpPr>
        <p:grpSp>
          <p:nvGrpSpPr>
            <p:cNvPr id="18" name="Group 17"/>
            <p:cNvGrpSpPr/>
            <p:nvPr/>
          </p:nvGrpSpPr>
          <p:grpSpPr>
            <a:xfrm>
              <a:off x="1055531" y="4478872"/>
              <a:ext cx="5063764" cy="1075514"/>
              <a:chOff x="1341966" y="4419600"/>
              <a:chExt cx="5063764" cy="1075514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341966" y="4419600"/>
                <a:ext cx="5063764" cy="575101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7"/>
              <a:srcRect b="50127"/>
              <a:stretch>
                <a:fillRect/>
              </a:stretch>
            </p:blipFill>
            <p:spPr>
              <a:xfrm>
                <a:off x="1358900" y="4994701"/>
                <a:ext cx="5046830" cy="500413"/>
              </a:xfrm>
              <a:prstGeom prst="rect">
                <a:avLst/>
              </a:prstGeom>
            </p:spPr>
          </p:pic>
        </p:grpSp>
        <p:sp>
          <p:nvSpPr>
            <p:cNvPr id="23" name="Rectangle 22"/>
            <p:cNvSpPr/>
            <p:nvPr/>
          </p:nvSpPr>
          <p:spPr>
            <a:xfrm>
              <a:off x="4724402" y="4386167"/>
              <a:ext cx="333375" cy="12190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5356227" y="4386167"/>
              <a:ext cx="333375" cy="12190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3640342" y="2353423"/>
            <a:ext cx="2626783" cy="1015908"/>
            <a:chOff x="1055531" y="3170863"/>
            <a:chExt cx="2626783" cy="1015908"/>
          </a:xfrm>
        </p:grpSpPr>
        <p:grpSp>
          <p:nvGrpSpPr>
            <p:cNvPr id="17" name="Group 16"/>
            <p:cNvGrpSpPr/>
            <p:nvPr/>
          </p:nvGrpSpPr>
          <p:grpSpPr>
            <a:xfrm>
              <a:off x="1055531" y="3267054"/>
              <a:ext cx="2626783" cy="830817"/>
              <a:chOff x="1358900" y="3156983"/>
              <a:chExt cx="2626783" cy="830817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358900" y="3156983"/>
                <a:ext cx="2626783" cy="424418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/>
              <a:srcRect l="5143" r="5143" b="61463"/>
              <a:stretch>
                <a:fillRect/>
              </a:stretch>
            </p:blipFill>
            <p:spPr>
              <a:xfrm>
                <a:off x="1380157" y="3581401"/>
                <a:ext cx="2586379" cy="406399"/>
              </a:xfrm>
              <a:prstGeom prst="rect">
                <a:avLst/>
              </a:prstGeom>
            </p:spPr>
          </p:pic>
        </p:grpSp>
        <p:sp>
          <p:nvSpPr>
            <p:cNvPr id="25" name="Rectangle 24"/>
            <p:cNvSpPr/>
            <p:nvPr/>
          </p:nvSpPr>
          <p:spPr>
            <a:xfrm>
              <a:off x="1076788" y="3170863"/>
              <a:ext cx="790114" cy="10159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1055531" y="5820842"/>
            <a:ext cx="4634071" cy="1426002"/>
            <a:chOff x="1055531" y="6040971"/>
            <a:chExt cx="3900983" cy="1426002"/>
          </a:xfrm>
        </p:grpSpPr>
        <p:grpSp>
          <p:nvGrpSpPr>
            <p:cNvPr id="19" name="Group 18"/>
            <p:cNvGrpSpPr/>
            <p:nvPr/>
          </p:nvGrpSpPr>
          <p:grpSpPr>
            <a:xfrm>
              <a:off x="1055531" y="6130621"/>
              <a:ext cx="3900983" cy="1222052"/>
              <a:chOff x="1157129" y="6020550"/>
              <a:chExt cx="3900983" cy="1222052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157129" y="6020550"/>
                <a:ext cx="3898203" cy="798720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11"/>
              <a:srcRect l="10485" b="58065"/>
              <a:stretch>
                <a:fillRect/>
              </a:stretch>
            </p:blipFill>
            <p:spPr>
              <a:xfrm>
                <a:off x="1250276" y="6942668"/>
                <a:ext cx="3807836" cy="299934"/>
              </a:xfrm>
              <a:prstGeom prst="rect">
                <a:avLst/>
              </a:prstGeom>
            </p:spPr>
          </p:pic>
        </p:grpSp>
        <p:sp>
          <p:nvSpPr>
            <p:cNvPr id="26" name="Rectangle 25"/>
            <p:cNvSpPr/>
            <p:nvPr/>
          </p:nvSpPr>
          <p:spPr>
            <a:xfrm>
              <a:off x="4229102" y="6040971"/>
              <a:ext cx="495300" cy="142600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494801" y="173624"/>
            <a:ext cx="893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3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80450" y="7605789"/>
            <a:ext cx="61711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3. PCFS4-TAP enrichment sites are associated with the sites where the alternative transcription or pre-mRNA processing occurs. The gene structures are represented by blue bars (light blue bars for 5’ and 3’ UTR) and lines (</a:t>
            </a:r>
            <a:r>
              <a:rPr lang="en-US" sz="1200" b="1" dirty="0" smtClean="0"/>
              <a:t>Gene model). </a:t>
            </a:r>
            <a:r>
              <a:rPr lang="en-US" sz="1200" dirty="0" smtClean="0"/>
              <a:t>The </a:t>
            </a:r>
            <a:r>
              <a:rPr lang="en-US" sz="1200" dirty="0" err="1" smtClean="0"/>
              <a:t>cDNA</a:t>
            </a:r>
            <a:r>
              <a:rPr lang="en-US" sz="1200" dirty="0" smtClean="0"/>
              <a:t>/ESTs supporting the gene model are represented by green bars (</a:t>
            </a:r>
            <a:r>
              <a:rPr lang="en-US" sz="1200" b="1" dirty="0" err="1" smtClean="0"/>
              <a:t>cDNA</a:t>
            </a:r>
            <a:r>
              <a:rPr lang="en-US" sz="1200" b="1" dirty="0" smtClean="0"/>
              <a:t>/EST</a:t>
            </a:r>
            <a:r>
              <a:rPr lang="en-US" sz="1200" dirty="0" smtClean="0"/>
              <a:t>). The vertical black bars represent the PCFS4-TAP enrichment (</a:t>
            </a:r>
            <a:r>
              <a:rPr lang="en-US" sz="1200" b="1" dirty="0" smtClean="0"/>
              <a:t>Log fold enrichment</a:t>
            </a:r>
            <a:r>
              <a:rPr lang="en-US" sz="1200" dirty="0" smtClean="0"/>
              <a:t>)</a:t>
            </a:r>
            <a:r>
              <a:rPr lang="en-US" sz="1200" b="1" dirty="0" smtClean="0"/>
              <a:t> </a:t>
            </a:r>
            <a:r>
              <a:rPr lang="en-US" sz="1200" dirty="0" smtClean="0"/>
              <a:t>along the gene body. The red frames highlight the regions where the ES site are associated with alternative transcription or pre-mRNA processing supported by </a:t>
            </a:r>
            <a:r>
              <a:rPr lang="en-US" sz="1200" dirty="0" err="1" smtClean="0"/>
              <a:t>cDNA</a:t>
            </a:r>
            <a:r>
              <a:rPr lang="en-US" sz="1200" dirty="0" smtClean="0"/>
              <a:t>/ESTs.</a:t>
            </a:r>
            <a:endParaRPr lang="en-US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245032" y="647704"/>
            <a:ext cx="827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 Model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245032" y="1007884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DNA</a:t>
            </a:r>
            <a:r>
              <a:rPr lang="en-US" sz="1000" dirty="0" smtClean="0"/>
              <a:t>/EST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245032" y="1413940"/>
            <a:ext cx="827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og fold enrichment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280450" y="2378948"/>
            <a:ext cx="827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 Model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280450" y="2696793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DNA</a:t>
            </a:r>
            <a:r>
              <a:rPr lang="en-US" sz="1000" dirty="0" smtClean="0"/>
              <a:t>/EST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280450" y="3085915"/>
            <a:ext cx="827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og fold enrichment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245032" y="4208376"/>
            <a:ext cx="827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 Model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245032" y="4534688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DNA</a:t>
            </a:r>
            <a:r>
              <a:rPr lang="en-US" sz="1000" dirty="0" smtClean="0"/>
              <a:t>/EST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245032" y="4898409"/>
            <a:ext cx="827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og fold enrichment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228098" y="5866319"/>
            <a:ext cx="827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 Model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228098" y="6302702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DNA</a:t>
            </a:r>
            <a:r>
              <a:rPr lang="en-US" sz="1000" dirty="0" smtClean="0"/>
              <a:t>/EST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228098" y="6818829"/>
            <a:ext cx="827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Log fold enrichment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1072465" y="5636176"/>
            <a:ext cx="90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3G20810</a:t>
            </a:r>
            <a:endParaRPr lang="en-US" sz="12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166183" y="3838240"/>
            <a:ext cx="908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3G22380</a:t>
            </a:r>
            <a:endParaRPr 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1055531" y="2042680"/>
            <a:ext cx="908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5G48890</a:t>
            </a:r>
            <a:endParaRPr lang="en-US" sz="12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661599" y="2042680"/>
            <a:ext cx="908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3G26640</a:t>
            </a:r>
            <a:endParaRPr lang="en-US" sz="12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107883" y="481401"/>
            <a:ext cx="908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T5G52910</a:t>
            </a:r>
            <a:endParaRPr lang="en-US" sz="1200" b="1" dirty="0"/>
          </a:p>
        </p:txBody>
      </p:sp>
      <p:sp>
        <p:nvSpPr>
          <p:cNvPr id="52" name="Rectangle 51"/>
          <p:cNvSpPr/>
          <p:nvPr/>
        </p:nvSpPr>
        <p:spPr>
          <a:xfrm>
            <a:off x="1093842" y="5792937"/>
            <a:ext cx="588379" cy="14260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5581340" y="2366078"/>
            <a:ext cx="790114" cy="1015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314</Words>
  <Application>Microsoft Macintosh PowerPoint</Application>
  <PresentationFormat>On-screen Show (4:3)</PresentationFormat>
  <Paragraphs>26</Paragraphs>
  <Slides>3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Miami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nghui Xing</dc:creator>
  <cp:lastModifiedBy>Denghui Xing</cp:lastModifiedBy>
  <cp:revision>21</cp:revision>
  <dcterms:created xsi:type="dcterms:W3CDTF">2012-10-29T17:23:24Z</dcterms:created>
  <dcterms:modified xsi:type="dcterms:W3CDTF">2012-10-29T17:26:28Z</dcterms:modified>
</cp:coreProperties>
</file>